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1476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Classeur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chart>
    <c:plotArea>
      <c:layout>
        <c:manualLayout>
          <c:layoutTarget val="inner"/>
          <c:xMode val="edge"/>
          <c:yMode val="edge"/>
          <c:x val="4.5950047467470785E-2"/>
          <c:y val="6.0659813356663754E-2"/>
          <c:w val="0.78616434913720601"/>
          <c:h val="0.89719889180519286"/>
        </c:manualLayout>
      </c:layout>
      <c:scatterChart>
        <c:scatterStyle val="smoothMarker"/>
        <c:ser>
          <c:idx val="0"/>
          <c:order val="0"/>
          <c:tx>
            <c:strRef>
              <c:f>Feuil1!$A$16</c:f>
              <c:strCache>
                <c:ptCount val="1"/>
                <c:pt idx="0">
                  <c:v>1021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Feuil1!$B$23:$M$23</c:f>
                <c:numCache>
                  <c:formatCode>General</c:formatCode>
                  <c:ptCount val="12"/>
                  <c:pt idx="0">
                    <c:v>0</c:v>
                  </c:pt>
                  <c:pt idx="1">
                    <c:v>0</c:v>
                  </c:pt>
                  <c:pt idx="2">
                    <c:v>0.22360679774997891</c:v>
                  </c:pt>
                  <c:pt idx="3">
                    <c:v>0.44721359549995876</c:v>
                  </c:pt>
                  <c:pt idx="4">
                    <c:v>2.6337885460422203</c:v>
                  </c:pt>
                  <c:pt idx="5">
                    <c:v>2.7815179498366009</c:v>
                  </c:pt>
                  <c:pt idx="6">
                    <c:v>3.0757968586676063</c:v>
                  </c:pt>
                  <c:pt idx="7">
                    <c:v>3.3779470563923177</c:v>
                  </c:pt>
                  <c:pt idx="8">
                    <c:v>4.5375625267549236</c:v>
                  </c:pt>
                  <c:pt idx="9">
                    <c:v>4.3706557378667297</c:v>
                  </c:pt>
                  <c:pt idx="10">
                    <c:v>4.4721359549995796</c:v>
                  </c:pt>
                  <c:pt idx="11">
                    <c:v>7.2799291494528191</c:v>
                  </c:pt>
                </c:numCache>
              </c:numRef>
            </c:plus>
            <c:minus>
              <c:numRef>
                <c:f>Feuil1!$B$23:$M$23</c:f>
                <c:numCache>
                  <c:formatCode>General</c:formatCode>
                  <c:ptCount val="12"/>
                  <c:pt idx="0">
                    <c:v>0</c:v>
                  </c:pt>
                  <c:pt idx="1">
                    <c:v>0</c:v>
                  </c:pt>
                  <c:pt idx="2">
                    <c:v>0.22360679774997891</c:v>
                  </c:pt>
                  <c:pt idx="3">
                    <c:v>0.44721359549995876</c:v>
                  </c:pt>
                  <c:pt idx="4">
                    <c:v>2.6337885460422203</c:v>
                  </c:pt>
                  <c:pt idx="5">
                    <c:v>2.7815179498366009</c:v>
                  </c:pt>
                  <c:pt idx="6">
                    <c:v>3.0757968586676063</c:v>
                  </c:pt>
                  <c:pt idx="7">
                    <c:v>3.3779470563923177</c:v>
                  </c:pt>
                  <c:pt idx="8">
                    <c:v>4.5375625267549236</c:v>
                  </c:pt>
                  <c:pt idx="9">
                    <c:v>4.3706557378667297</c:v>
                  </c:pt>
                  <c:pt idx="10">
                    <c:v>4.4721359549995796</c:v>
                  </c:pt>
                  <c:pt idx="11">
                    <c:v>7.2799291494528191</c:v>
                  </c:pt>
                </c:numCache>
              </c:numRef>
            </c:minus>
          </c:errBars>
          <c:xVal>
            <c:numRef>
              <c:f>Feuil1!$B$15:$M$15</c:f>
              <c:numCache>
                <c:formatCode>General</c:formatCode>
                <c:ptCount val="12"/>
                <c:pt idx="0">
                  <c:v>5</c:v>
                </c:pt>
                <c:pt idx="1">
                  <c:v>6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0</c:v>
                </c:pt>
                <c:pt idx="6">
                  <c:v>11</c:v>
                </c:pt>
                <c:pt idx="7">
                  <c:v>12</c:v>
                </c:pt>
                <c:pt idx="8">
                  <c:v>14</c:v>
                </c:pt>
                <c:pt idx="9">
                  <c:v>18</c:v>
                </c:pt>
                <c:pt idx="10">
                  <c:v>27</c:v>
                </c:pt>
                <c:pt idx="11">
                  <c:v>39</c:v>
                </c:pt>
              </c:numCache>
            </c:numRef>
          </c:xVal>
          <c:yVal>
            <c:numRef>
              <c:f>Feuil1!$B$16:$M$16</c:f>
              <c:numCache>
                <c:formatCode>General</c:formatCode>
                <c:ptCount val="1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.1</c:v>
                </c:pt>
                <c:pt idx="4">
                  <c:v>1</c:v>
                </c:pt>
                <c:pt idx="5">
                  <c:v>1.750000000000002</c:v>
                </c:pt>
                <c:pt idx="6">
                  <c:v>2.0499999999999998</c:v>
                </c:pt>
                <c:pt idx="7">
                  <c:v>4.25</c:v>
                </c:pt>
                <c:pt idx="8">
                  <c:v>5.35</c:v>
                </c:pt>
                <c:pt idx="9">
                  <c:v>7.9</c:v>
                </c:pt>
                <c:pt idx="10">
                  <c:v>10.450000000000006</c:v>
                </c:pt>
                <c:pt idx="11">
                  <c:v>17.100000000000001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Feuil1!$A$17</c:f>
              <c:strCache>
                <c:ptCount val="1"/>
                <c:pt idx="0">
                  <c:v>1021 queF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Feuil1!$B$23:$M$23</c:f>
                <c:numCache>
                  <c:formatCode>General</c:formatCode>
                  <c:ptCount val="12"/>
                  <c:pt idx="0">
                    <c:v>0</c:v>
                  </c:pt>
                  <c:pt idx="1">
                    <c:v>0</c:v>
                  </c:pt>
                  <c:pt idx="2">
                    <c:v>0.22360679774997891</c:v>
                  </c:pt>
                  <c:pt idx="3">
                    <c:v>0.44721359549995876</c:v>
                  </c:pt>
                  <c:pt idx="4">
                    <c:v>2.6337885460422203</c:v>
                  </c:pt>
                  <c:pt idx="5">
                    <c:v>2.7815179498366009</c:v>
                  </c:pt>
                  <c:pt idx="6">
                    <c:v>3.0757968586676063</c:v>
                  </c:pt>
                  <c:pt idx="7">
                    <c:v>3.3779470563923177</c:v>
                  </c:pt>
                  <c:pt idx="8">
                    <c:v>4.5375625267549236</c:v>
                  </c:pt>
                  <c:pt idx="9">
                    <c:v>4.3706557378667297</c:v>
                  </c:pt>
                  <c:pt idx="10">
                    <c:v>4.4721359549995796</c:v>
                  </c:pt>
                  <c:pt idx="11">
                    <c:v>7.2799291494528191</c:v>
                  </c:pt>
                </c:numCache>
              </c:numRef>
            </c:plus>
            <c:minus>
              <c:numRef>
                <c:f>Feuil1!$B$23:$M$23</c:f>
                <c:numCache>
                  <c:formatCode>General</c:formatCode>
                  <c:ptCount val="12"/>
                  <c:pt idx="0">
                    <c:v>0</c:v>
                  </c:pt>
                  <c:pt idx="1">
                    <c:v>0</c:v>
                  </c:pt>
                  <c:pt idx="2">
                    <c:v>0.22360679774997891</c:v>
                  </c:pt>
                  <c:pt idx="3">
                    <c:v>0.44721359549995876</c:v>
                  </c:pt>
                  <c:pt idx="4">
                    <c:v>2.6337885460422203</c:v>
                  </c:pt>
                  <c:pt idx="5">
                    <c:v>2.7815179498366009</c:v>
                  </c:pt>
                  <c:pt idx="6">
                    <c:v>3.0757968586676063</c:v>
                  </c:pt>
                  <c:pt idx="7">
                    <c:v>3.3779470563923177</c:v>
                  </c:pt>
                  <c:pt idx="8">
                    <c:v>4.5375625267549236</c:v>
                  </c:pt>
                  <c:pt idx="9">
                    <c:v>4.3706557378667297</c:v>
                  </c:pt>
                  <c:pt idx="10">
                    <c:v>4.4721359549995796</c:v>
                  </c:pt>
                  <c:pt idx="11">
                    <c:v>7.2799291494528191</c:v>
                  </c:pt>
                </c:numCache>
              </c:numRef>
            </c:minus>
          </c:errBars>
          <c:xVal>
            <c:numRef>
              <c:f>Feuil1!$B$15:$M$15</c:f>
              <c:numCache>
                <c:formatCode>General</c:formatCode>
                <c:ptCount val="12"/>
                <c:pt idx="0">
                  <c:v>5</c:v>
                </c:pt>
                <c:pt idx="1">
                  <c:v>6</c:v>
                </c:pt>
                <c:pt idx="2">
                  <c:v>7</c:v>
                </c:pt>
                <c:pt idx="3">
                  <c:v>8</c:v>
                </c:pt>
                <c:pt idx="4">
                  <c:v>9</c:v>
                </c:pt>
                <c:pt idx="5">
                  <c:v>10</c:v>
                </c:pt>
                <c:pt idx="6">
                  <c:v>11</c:v>
                </c:pt>
                <c:pt idx="7">
                  <c:v>12</c:v>
                </c:pt>
                <c:pt idx="8">
                  <c:v>14</c:v>
                </c:pt>
                <c:pt idx="9">
                  <c:v>18</c:v>
                </c:pt>
                <c:pt idx="10">
                  <c:v>27</c:v>
                </c:pt>
                <c:pt idx="11">
                  <c:v>39</c:v>
                </c:pt>
              </c:numCache>
            </c:numRef>
          </c:xVal>
          <c:yVal>
            <c:numRef>
              <c:f>Feuil1!$B$17:$M$17</c:f>
              <c:numCache>
                <c:formatCode>General</c:formatCode>
                <c:ptCount val="12"/>
                <c:pt idx="0">
                  <c:v>0</c:v>
                </c:pt>
                <c:pt idx="1">
                  <c:v>0</c:v>
                </c:pt>
                <c:pt idx="2">
                  <c:v>5.0000000000000093E-2</c:v>
                </c:pt>
                <c:pt idx="3">
                  <c:v>0.1</c:v>
                </c:pt>
                <c:pt idx="4">
                  <c:v>1.1000000000000001</c:v>
                </c:pt>
                <c:pt idx="5">
                  <c:v>1.5</c:v>
                </c:pt>
                <c:pt idx="6">
                  <c:v>1.750000000000002</c:v>
                </c:pt>
                <c:pt idx="7">
                  <c:v>3.4</c:v>
                </c:pt>
                <c:pt idx="8">
                  <c:v>4.8</c:v>
                </c:pt>
                <c:pt idx="9">
                  <c:v>8.4500000000000028</c:v>
                </c:pt>
                <c:pt idx="10">
                  <c:v>13</c:v>
                </c:pt>
                <c:pt idx="11">
                  <c:v>21.05</c:v>
                </c:pt>
              </c:numCache>
            </c:numRef>
          </c:yVal>
          <c:smooth val="1"/>
        </c:ser>
        <c:axId val="63054208"/>
        <c:axId val="63055744"/>
      </c:scatterChart>
      <c:valAx>
        <c:axId val="63054208"/>
        <c:scaling>
          <c:orientation val="minMax"/>
        </c:scaling>
        <c:axPos val="b"/>
        <c:numFmt formatCode="General" sourceLinked="1"/>
        <c:tickLblPos val="nextTo"/>
        <c:crossAx val="63055744"/>
        <c:crosses val="autoZero"/>
        <c:crossBetween val="midCat"/>
      </c:valAx>
      <c:valAx>
        <c:axId val="63055744"/>
        <c:scaling>
          <c:orientation val="minMax"/>
          <c:min val="0"/>
        </c:scaling>
        <c:axPos val="l"/>
        <c:majorGridlines/>
        <c:numFmt formatCode="General" sourceLinked="1"/>
        <c:tickLblPos val="nextTo"/>
        <c:crossAx val="63054208"/>
        <c:crosses val="autoZero"/>
        <c:crossBetween val="midCat"/>
      </c:valAx>
    </c:plotArea>
    <c:legend>
      <c:legendPos val="r"/>
      <c:legendEntry>
        <c:idx val="1"/>
        <c:txPr>
          <a:bodyPr/>
          <a:lstStyle/>
          <a:p>
            <a:pPr>
              <a:defRPr i="1"/>
            </a:pPr>
            <a:endParaRPr lang="fr-FR"/>
          </a:p>
        </c:txPr>
      </c:legendEntry>
      <c:layout>
        <c:manualLayout>
          <c:xMode val="edge"/>
          <c:yMode val="edge"/>
          <c:x val="4.6773049645390072E-2"/>
          <c:y val="6.4430956547098531E-2"/>
          <c:w val="0.17308510638297891"/>
          <c:h val="0.19984179060950721"/>
        </c:manualLayout>
      </c:layout>
    </c:legend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7C7A-3527-4739-9769-DFFF91E49A88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BA049-6B0C-4F04-8DB3-5B3620885A4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7C7A-3527-4739-9769-DFFF91E49A88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BA049-6B0C-4F04-8DB3-5B3620885A4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7C7A-3527-4739-9769-DFFF91E49A88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BA049-6B0C-4F04-8DB3-5B3620885A4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7C7A-3527-4739-9769-DFFF91E49A88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BA049-6B0C-4F04-8DB3-5B3620885A4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7C7A-3527-4739-9769-DFFF91E49A88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BA049-6B0C-4F04-8DB3-5B3620885A4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7C7A-3527-4739-9769-DFFF91E49A88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BA049-6B0C-4F04-8DB3-5B3620885A4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7C7A-3527-4739-9769-DFFF91E49A88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BA049-6B0C-4F04-8DB3-5B3620885A4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7C7A-3527-4739-9769-DFFF91E49A88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BA049-6B0C-4F04-8DB3-5B3620885A4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7C7A-3527-4739-9769-DFFF91E49A88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BA049-6B0C-4F04-8DB3-5B3620885A4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7C7A-3527-4739-9769-DFFF91E49A88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BA049-6B0C-4F04-8DB3-5B3620885A4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47C7A-3527-4739-9769-DFFF91E49A88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8BA049-6B0C-4F04-8DB3-5B3620885A4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547C7A-3527-4739-9769-DFFF91E49A88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8BA049-6B0C-4F04-8DB3-5B3620885A4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/>
          <p:nvPr/>
        </p:nvGraphicFramePr>
        <p:xfrm>
          <a:off x="1052735" y="1835696"/>
          <a:ext cx="5400600" cy="20231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ZoneTexte 4"/>
          <p:cNvSpPr txBox="1"/>
          <p:nvPr/>
        </p:nvSpPr>
        <p:spPr>
          <a:xfrm>
            <a:off x="2708920" y="3923928"/>
            <a:ext cx="1520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Days</a:t>
            </a:r>
            <a:r>
              <a:rPr lang="fr-FR" sz="1200" dirty="0" smtClean="0"/>
              <a:t> post inoculation</a:t>
            </a:r>
            <a:endParaRPr lang="fr-FR" sz="1200" dirty="0"/>
          </a:p>
        </p:txBody>
      </p:sp>
      <p:sp>
        <p:nvSpPr>
          <p:cNvPr id="6" name="ZoneTexte 5"/>
          <p:cNvSpPr txBox="1"/>
          <p:nvPr/>
        </p:nvSpPr>
        <p:spPr>
          <a:xfrm rot="16200000">
            <a:off x="90448" y="2653969"/>
            <a:ext cx="14814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N° of nodules/plant</a:t>
            </a:r>
            <a:endParaRPr lang="fr-FR" sz="1200" dirty="0"/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476672" y="4880357"/>
            <a:ext cx="5877272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Figure S6.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Nodulation kinetics of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S. </a:t>
            </a:r>
            <a:r>
              <a:rPr kumimoji="0" lang="en-US" sz="12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meliloti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1021 and </a:t>
            </a:r>
            <a:r>
              <a:rPr kumimoji="0" lang="en-US" sz="12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queF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mutant on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M. </a:t>
            </a:r>
            <a:r>
              <a:rPr kumimoji="0" lang="en-US" sz="12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truncatula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seedlings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.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20 plants were tested per strain.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33</Words>
  <Application>Microsoft Office PowerPoint</Application>
  <PresentationFormat>Affichage à l'écran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cmasson</dc:creator>
  <cp:lastModifiedBy>mmarchet</cp:lastModifiedBy>
  <cp:revision>9</cp:revision>
  <dcterms:created xsi:type="dcterms:W3CDTF">2012-04-24T15:49:43Z</dcterms:created>
  <dcterms:modified xsi:type="dcterms:W3CDTF">2013-01-11T10:58:34Z</dcterms:modified>
</cp:coreProperties>
</file>